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1632" y="156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A94F-155D-4175-89AE-E436DBEF4838}" type="datetimeFigureOut">
              <a:rPr lang="zh-TW" altLang="en-US" smtClean="0"/>
              <a:t>2024/6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EAD6E-B664-4BA6-AF14-002E3D2D663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69799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A94F-155D-4175-89AE-E436DBEF4838}" type="datetimeFigureOut">
              <a:rPr lang="zh-TW" altLang="en-US" smtClean="0"/>
              <a:t>2024/6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EAD6E-B664-4BA6-AF14-002E3D2D663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46274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A94F-155D-4175-89AE-E436DBEF4838}" type="datetimeFigureOut">
              <a:rPr lang="zh-TW" altLang="en-US" smtClean="0"/>
              <a:t>2024/6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EAD6E-B664-4BA6-AF14-002E3D2D663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9418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A94F-155D-4175-89AE-E436DBEF4838}" type="datetimeFigureOut">
              <a:rPr lang="zh-TW" altLang="en-US" smtClean="0"/>
              <a:t>2024/6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EAD6E-B664-4BA6-AF14-002E3D2D663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76433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A94F-155D-4175-89AE-E436DBEF4838}" type="datetimeFigureOut">
              <a:rPr lang="zh-TW" altLang="en-US" smtClean="0"/>
              <a:t>2024/6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EAD6E-B664-4BA6-AF14-002E3D2D663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19592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A94F-155D-4175-89AE-E436DBEF4838}" type="datetimeFigureOut">
              <a:rPr lang="zh-TW" altLang="en-US" smtClean="0"/>
              <a:t>2024/6/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EAD6E-B664-4BA6-AF14-002E3D2D663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382706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A94F-155D-4175-89AE-E436DBEF4838}" type="datetimeFigureOut">
              <a:rPr lang="zh-TW" altLang="en-US" smtClean="0"/>
              <a:t>2024/6/9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EAD6E-B664-4BA6-AF14-002E3D2D663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709886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A94F-155D-4175-89AE-E436DBEF4838}" type="datetimeFigureOut">
              <a:rPr lang="zh-TW" altLang="en-US" smtClean="0"/>
              <a:t>2024/6/9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EAD6E-B664-4BA6-AF14-002E3D2D663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42570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A94F-155D-4175-89AE-E436DBEF4838}" type="datetimeFigureOut">
              <a:rPr lang="zh-TW" altLang="en-US" smtClean="0"/>
              <a:t>2024/6/9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EAD6E-B664-4BA6-AF14-002E3D2D663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13876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A94F-155D-4175-89AE-E436DBEF4838}" type="datetimeFigureOut">
              <a:rPr lang="zh-TW" altLang="en-US" smtClean="0"/>
              <a:t>2024/6/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EAD6E-B664-4BA6-AF14-002E3D2D663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29083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A94F-155D-4175-89AE-E436DBEF4838}" type="datetimeFigureOut">
              <a:rPr lang="zh-TW" altLang="en-US" smtClean="0"/>
              <a:t>2024/6/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EAD6E-B664-4BA6-AF14-002E3D2D663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62378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419A94F-155D-4175-89AE-E436DBEF4838}" type="datetimeFigureOut">
              <a:rPr lang="zh-TW" altLang="en-US" smtClean="0"/>
              <a:t>2024/6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3DEAD6E-B664-4BA6-AF14-002E3D2D663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70901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1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2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>
            <a:extLst>
              <a:ext uri="{FF2B5EF4-FFF2-40B4-BE49-F238E27FC236}">
                <a16:creationId xmlns:a16="http://schemas.microsoft.com/office/drawing/2014/main" id="{865E3390-F607-DDF6-8172-A5644D3A79D2}"/>
              </a:ext>
            </a:extLst>
          </p:cNvPr>
          <p:cNvSpPr txBox="1"/>
          <p:nvPr/>
        </p:nvSpPr>
        <p:spPr>
          <a:xfrm>
            <a:off x="0" y="5629095"/>
            <a:ext cx="99060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 Linkage disequilibrium relationship between the 16 SNPs identified in this study and previously published SNPs associated with COPD and lung function traits. (A) Chromosome 2_rs58352046_rs76053630_rs60298813, (B) Chromosome 2_rs2881881_rs6735908, (C) Chromosome 3_rs6802474_rs11925206_rs6783721, (D) Chromosome 8_rs12682151, (E) Chromosome 9_rs10780705_rs11140930_rs10511980, (F) Chromosome 15_rs1994147, (G) Chromosome 18_rs1786166, (H) Chromosome 21_rs57220716. The </a:t>
            </a:r>
            <a:r>
              <a:rPr lang="en-US" altLang="zh-TW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s</a:t>
            </a:r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 marked in red (right table) was the SNP found to be highly associated with COPD in this study.</a:t>
            </a:r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5874F6A4-BA26-4D31-0098-AEA9BCFEF377}"/>
              </a:ext>
            </a:extLst>
          </p:cNvPr>
          <p:cNvSpPr txBox="1"/>
          <p:nvPr/>
        </p:nvSpPr>
        <p:spPr>
          <a:xfrm>
            <a:off x="0" y="0"/>
            <a:ext cx="21371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ry Figure S4)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E2C90767-34DC-0F7F-F229-18F7129633CD}"/>
              </a:ext>
            </a:extLst>
          </p:cNvPr>
          <p:cNvSpPr txBox="1"/>
          <p:nvPr/>
        </p:nvSpPr>
        <p:spPr>
          <a:xfrm>
            <a:off x="0" y="376335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圖片 5" descr="一張含有 文字, 螢幕擷取畫面, 圖表, 行 的圖片&#10;&#10;自動產生的描述">
            <a:extLst>
              <a:ext uri="{FF2B5EF4-FFF2-40B4-BE49-F238E27FC236}">
                <a16:creationId xmlns:a16="http://schemas.microsoft.com/office/drawing/2014/main" id="{A497CA4E-EB3A-32A8-8B71-8CC307026B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139" y="469266"/>
            <a:ext cx="4650821" cy="5159829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4F992B62-D831-2E90-ADCE-7B2B19A38E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21134" y="1360305"/>
            <a:ext cx="4757349" cy="1086733"/>
          </a:xfrm>
          <a:prstGeom prst="rect">
            <a:avLst/>
          </a:prstGeom>
        </p:spPr>
      </p:pic>
      <p:pic>
        <p:nvPicPr>
          <p:cNvPr id="8" name="圖片 7">
            <a:extLst>
              <a:ext uri="{FF2B5EF4-FFF2-40B4-BE49-F238E27FC236}">
                <a16:creationId xmlns:a16="http://schemas.microsoft.com/office/drawing/2014/main" id="{415040F9-6275-9D29-489A-5B40F139194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21134" y="2695771"/>
            <a:ext cx="4757347" cy="1086733"/>
          </a:xfrm>
          <a:prstGeom prst="rect">
            <a:avLst/>
          </a:prstGeom>
        </p:spPr>
      </p:pic>
      <p:pic>
        <p:nvPicPr>
          <p:cNvPr id="10" name="圖片 9" descr="一張含有 文字, 螢幕擷取畫面, 字型, 數字 的圖片&#10;&#10;自動產生的描述">
            <a:extLst>
              <a:ext uri="{FF2B5EF4-FFF2-40B4-BE49-F238E27FC236}">
                <a16:creationId xmlns:a16="http://schemas.microsoft.com/office/drawing/2014/main" id="{1FCA8304-B303-ACE4-E04C-53A92289DA0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4975" y="4740733"/>
            <a:ext cx="1646825" cy="756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11644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93EF461F-322A-A10A-49CD-1597C9AE64B9}"/>
              </a:ext>
            </a:extLst>
          </p:cNvPr>
          <p:cNvSpPr txBox="1"/>
          <p:nvPr/>
        </p:nvSpPr>
        <p:spPr>
          <a:xfrm>
            <a:off x="0" y="0"/>
            <a:ext cx="29354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ry Figure S4, continued)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B0B84B84-DBB8-6496-6534-F64095B4DB46}"/>
              </a:ext>
            </a:extLst>
          </p:cNvPr>
          <p:cNvSpPr txBox="1"/>
          <p:nvPr/>
        </p:nvSpPr>
        <p:spPr>
          <a:xfrm>
            <a:off x="0" y="376335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圖片 4" descr="一張含有 文字, 螢幕擷取畫面, 圖表, 正方形 的圖片&#10;&#10;自動產生的描述">
            <a:extLst>
              <a:ext uri="{FF2B5EF4-FFF2-40B4-BE49-F238E27FC236}">
                <a16:creationId xmlns:a16="http://schemas.microsoft.com/office/drawing/2014/main" id="{E9DF5104-2FE3-984F-A895-5084F72A51B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757" y="752670"/>
            <a:ext cx="4660129" cy="5225143"/>
          </a:xfrm>
          <a:prstGeom prst="rect">
            <a:avLst/>
          </a:prstGeom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id="{83D5AC61-3DE0-C312-6851-F110DBD7D2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3000" y="1590389"/>
            <a:ext cx="4861345" cy="1065607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1444E8BF-3AE7-572B-2CF7-00E18957697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53001" y="3084260"/>
            <a:ext cx="4861346" cy="1065607"/>
          </a:xfrm>
          <a:prstGeom prst="rect">
            <a:avLst/>
          </a:prstGeom>
        </p:spPr>
      </p:pic>
      <p:pic>
        <p:nvPicPr>
          <p:cNvPr id="8" name="圖片 7" descr="一張含有 文字, 螢幕擷取畫面, 字型, 數字 的圖片&#10;&#10;自動產生的描述">
            <a:extLst>
              <a:ext uri="{FF2B5EF4-FFF2-40B4-BE49-F238E27FC236}">
                <a16:creationId xmlns:a16="http://schemas.microsoft.com/office/drawing/2014/main" id="{4BFA1366-0EE5-58AF-F485-5D380162FF3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4975" y="5220851"/>
            <a:ext cx="1646825" cy="756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72705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FD265DDC-BCFB-BDE1-1FAB-3E0FF072752C}"/>
              </a:ext>
            </a:extLst>
          </p:cNvPr>
          <p:cNvSpPr txBox="1"/>
          <p:nvPr/>
        </p:nvSpPr>
        <p:spPr>
          <a:xfrm>
            <a:off x="0" y="0"/>
            <a:ext cx="29354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ry Figure S4, continued)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9ECC1457-2348-B2A1-6F11-06D855C1AD7F}"/>
              </a:ext>
            </a:extLst>
          </p:cNvPr>
          <p:cNvSpPr txBox="1"/>
          <p:nvPr/>
        </p:nvSpPr>
        <p:spPr>
          <a:xfrm>
            <a:off x="0" y="376335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圖片 4" descr="一張含有 文字, 螢幕擷取畫面, 圖表, 行 的圖片&#10;&#10;自動產生的描述">
            <a:extLst>
              <a:ext uri="{FF2B5EF4-FFF2-40B4-BE49-F238E27FC236}">
                <a16:creationId xmlns:a16="http://schemas.microsoft.com/office/drawing/2014/main" id="{C4E65C0E-BFEA-237D-9FD9-0A676C7246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589" y="684112"/>
            <a:ext cx="4622551" cy="5173763"/>
          </a:xfrm>
          <a:prstGeom prst="rect">
            <a:avLst/>
          </a:prstGeom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id="{E15567B5-01D4-2611-BD95-FFEEF278DAF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3000" y="1447800"/>
            <a:ext cx="4852173" cy="1162049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7AADC13B-6794-8789-0BDD-DDEBF3FCA0B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53000" y="3270993"/>
            <a:ext cx="4852172" cy="1162049"/>
          </a:xfrm>
          <a:prstGeom prst="rect">
            <a:avLst/>
          </a:prstGeom>
        </p:spPr>
      </p:pic>
      <p:pic>
        <p:nvPicPr>
          <p:cNvPr id="8" name="圖片 7" descr="一張含有 文字, 螢幕擷取畫面, 字型, 數字 的圖片&#10;&#10;自動產生的描述">
            <a:extLst>
              <a:ext uri="{FF2B5EF4-FFF2-40B4-BE49-F238E27FC236}">
                <a16:creationId xmlns:a16="http://schemas.microsoft.com/office/drawing/2014/main" id="{6E9B0DD6-406E-EC32-0969-35FDDC30C12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1862" y="5100913"/>
            <a:ext cx="1646825" cy="756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87570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3BEAFD2C-4709-F846-2792-E442D7DA34BB}"/>
              </a:ext>
            </a:extLst>
          </p:cNvPr>
          <p:cNvSpPr txBox="1"/>
          <p:nvPr/>
        </p:nvSpPr>
        <p:spPr>
          <a:xfrm>
            <a:off x="0" y="0"/>
            <a:ext cx="29354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ry Figure S4, continued)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19DFF108-FD54-19D7-ACC4-119945259669}"/>
              </a:ext>
            </a:extLst>
          </p:cNvPr>
          <p:cNvSpPr txBox="1"/>
          <p:nvPr/>
        </p:nvSpPr>
        <p:spPr>
          <a:xfrm>
            <a:off x="0" y="376335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圖片 4" descr="一張含有 文字, 螢幕擷取畫面, 圖表, 正方形 的圖片&#10;&#10;自動產生的描述">
            <a:extLst>
              <a:ext uri="{FF2B5EF4-FFF2-40B4-BE49-F238E27FC236}">
                <a16:creationId xmlns:a16="http://schemas.microsoft.com/office/drawing/2014/main" id="{799F3AEE-F186-ED23-9C42-D8E9315999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567" y="752670"/>
            <a:ext cx="4733634" cy="5238555"/>
          </a:xfrm>
          <a:prstGeom prst="rect">
            <a:avLst/>
          </a:prstGeom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id="{7FBB8796-4803-8FB8-5A43-7CB533FE51D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3000" y="1665889"/>
            <a:ext cx="4883656" cy="1105886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77C40F5A-3692-B5EA-9BB6-23A5E850F42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53000" y="3216668"/>
            <a:ext cx="4883657" cy="1105886"/>
          </a:xfrm>
          <a:prstGeom prst="rect">
            <a:avLst/>
          </a:prstGeom>
        </p:spPr>
      </p:pic>
      <p:sp>
        <p:nvSpPr>
          <p:cNvPr id="8" name="文字方塊 7">
            <a:extLst>
              <a:ext uri="{FF2B5EF4-FFF2-40B4-BE49-F238E27FC236}">
                <a16:creationId xmlns:a16="http://schemas.microsoft.com/office/drawing/2014/main" id="{A879490B-1591-B36C-39C0-B876EB00A6F3}"/>
              </a:ext>
            </a:extLst>
          </p:cNvPr>
          <p:cNvSpPr txBox="1"/>
          <p:nvPr/>
        </p:nvSpPr>
        <p:spPr>
          <a:xfrm>
            <a:off x="4981575" y="4353012"/>
            <a:ext cx="3898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/>
              <a:t> rs189074270 is missing from 1000G (GRCh38 High Coverage) data.</a:t>
            </a:r>
          </a:p>
        </p:txBody>
      </p:sp>
      <p:pic>
        <p:nvPicPr>
          <p:cNvPr id="9" name="圖片 8" descr="一張含有 文字, 螢幕擷取畫面, 字型, 數字 的圖片&#10;&#10;自動產生的描述">
            <a:extLst>
              <a:ext uri="{FF2B5EF4-FFF2-40B4-BE49-F238E27FC236}">
                <a16:creationId xmlns:a16="http://schemas.microsoft.com/office/drawing/2014/main" id="{ED0FEFBA-E3B2-CFD5-9867-83F00DAC2C9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1862" y="5100913"/>
            <a:ext cx="1646825" cy="756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18253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DAC4FD52-E55A-CC75-B35D-8E801CAF4F34}"/>
              </a:ext>
            </a:extLst>
          </p:cNvPr>
          <p:cNvSpPr txBox="1"/>
          <p:nvPr/>
        </p:nvSpPr>
        <p:spPr>
          <a:xfrm>
            <a:off x="0" y="0"/>
            <a:ext cx="29354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ry Figure S4, continued)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3EE5EEAF-9BC8-EBF8-724C-2A75CDAEAFFD}"/>
              </a:ext>
            </a:extLst>
          </p:cNvPr>
          <p:cNvSpPr txBox="1"/>
          <p:nvPr/>
        </p:nvSpPr>
        <p:spPr>
          <a:xfrm>
            <a:off x="0" y="376335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圖片 4" descr="一張含有 文字, 圖表, 螢幕擷取畫面, 行 的圖片&#10;&#10;自動產生的描述">
            <a:extLst>
              <a:ext uri="{FF2B5EF4-FFF2-40B4-BE49-F238E27FC236}">
                <a16:creationId xmlns:a16="http://schemas.microsoft.com/office/drawing/2014/main" id="{5D78AE71-50EA-B939-EE55-80F1CB21F1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146" y="684112"/>
            <a:ext cx="4746854" cy="5250857"/>
          </a:xfrm>
          <a:prstGeom prst="rect">
            <a:avLst/>
          </a:prstGeom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id="{D8D2443F-024C-0ED2-2198-34D647FE3E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3000" y="1415927"/>
            <a:ext cx="4889419" cy="1098674"/>
          </a:xfrm>
          <a:prstGeom prst="rect">
            <a:avLst/>
          </a:prstGeom>
        </p:spPr>
      </p:pic>
      <p:pic>
        <p:nvPicPr>
          <p:cNvPr id="8" name="圖片 7">
            <a:extLst>
              <a:ext uri="{FF2B5EF4-FFF2-40B4-BE49-F238E27FC236}">
                <a16:creationId xmlns:a16="http://schemas.microsoft.com/office/drawing/2014/main" id="{2B4903A8-89DD-EDF9-9CC7-4ECE47D1694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53000" y="2751116"/>
            <a:ext cx="4889425" cy="1098675"/>
          </a:xfrm>
          <a:prstGeom prst="rect">
            <a:avLst/>
          </a:prstGeom>
        </p:spPr>
      </p:pic>
      <p:pic>
        <p:nvPicPr>
          <p:cNvPr id="9" name="圖片 8" descr="一張含有 文字, 螢幕擷取畫面, 字型, 數字 的圖片&#10;&#10;自動產生的描述">
            <a:extLst>
              <a:ext uri="{FF2B5EF4-FFF2-40B4-BE49-F238E27FC236}">
                <a16:creationId xmlns:a16="http://schemas.microsoft.com/office/drawing/2014/main" id="{2A641386-26C6-6828-5704-B1285E71F6D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1862" y="5100913"/>
            <a:ext cx="1646825" cy="756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87913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B5456773-AC63-7A6C-BAA3-811A684A04AE}"/>
              </a:ext>
            </a:extLst>
          </p:cNvPr>
          <p:cNvSpPr txBox="1"/>
          <p:nvPr/>
        </p:nvSpPr>
        <p:spPr>
          <a:xfrm>
            <a:off x="0" y="0"/>
            <a:ext cx="29354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ry Figure S4, continued)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6B6F2693-DA17-D6F5-DC0B-B0461BA7DDFA}"/>
              </a:ext>
            </a:extLst>
          </p:cNvPr>
          <p:cNvSpPr txBox="1"/>
          <p:nvPr/>
        </p:nvSpPr>
        <p:spPr>
          <a:xfrm>
            <a:off x="0" y="376335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圖片 4" descr="一張含有 文字, 螢幕擷取畫面, 圖表, 行 的圖片&#10;&#10;自動產生的描述">
            <a:extLst>
              <a:ext uri="{FF2B5EF4-FFF2-40B4-BE49-F238E27FC236}">
                <a16:creationId xmlns:a16="http://schemas.microsoft.com/office/drawing/2014/main" id="{FEB16910-6A18-59C8-B353-567E8FFB6F9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146" y="684112"/>
            <a:ext cx="4759229" cy="5269013"/>
          </a:xfrm>
          <a:prstGeom prst="rect">
            <a:avLst/>
          </a:prstGeom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id="{DBC88D60-C17B-5C11-8F80-C317065277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65375" y="1533525"/>
            <a:ext cx="4883893" cy="1104900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C0301256-1389-E150-43B9-6E0A6EDD4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65375" y="3014760"/>
            <a:ext cx="4883893" cy="1104900"/>
          </a:xfrm>
          <a:prstGeom prst="rect">
            <a:avLst/>
          </a:prstGeom>
        </p:spPr>
      </p:pic>
      <p:pic>
        <p:nvPicPr>
          <p:cNvPr id="8" name="圖片 7" descr="一張含有 文字, 螢幕擷取畫面, 字型, 數字 的圖片&#10;&#10;自動產生的描述">
            <a:extLst>
              <a:ext uri="{FF2B5EF4-FFF2-40B4-BE49-F238E27FC236}">
                <a16:creationId xmlns:a16="http://schemas.microsoft.com/office/drawing/2014/main" id="{68D72DB1-3C04-F880-653F-625D3459D27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1862" y="5100913"/>
            <a:ext cx="1646825" cy="756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187724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273184D4-8FD2-A94D-1050-B28919E2FF4C}"/>
              </a:ext>
            </a:extLst>
          </p:cNvPr>
          <p:cNvSpPr txBox="1"/>
          <p:nvPr/>
        </p:nvSpPr>
        <p:spPr>
          <a:xfrm>
            <a:off x="0" y="0"/>
            <a:ext cx="29354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ry Figure S4, continued)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74736176-8823-4AFA-36A7-445006A82363}"/>
              </a:ext>
            </a:extLst>
          </p:cNvPr>
          <p:cNvSpPr txBox="1"/>
          <p:nvPr/>
        </p:nvSpPr>
        <p:spPr>
          <a:xfrm>
            <a:off x="0" y="376335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)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圖片 4" descr="一張含有 文字, 螢幕擷取畫面, 圖表, 行 的圖片&#10;&#10;自動產生的描述">
            <a:extLst>
              <a:ext uri="{FF2B5EF4-FFF2-40B4-BE49-F238E27FC236}">
                <a16:creationId xmlns:a16="http://schemas.microsoft.com/office/drawing/2014/main" id="{CCB59EEA-16A0-DC42-5FF9-C200DC92DA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566" y="684112"/>
            <a:ext cx="4748246" cy="5269013"/>
          </a:xfrm>
          <a:prstGeom prst="rect">
            <a:avLst/>
          </a:prstGeom>
        </p:spPr>
      </p:pic>
      <p:pic>
        <p:nvPicPr>
          <p:cNvPr id="8" name="圖片 7">
            <a:extLst>
              <a:ext uri="{FF2B5EF4-FFF2-40B4-BE49-F238E27FC236}">
                <a16:creationId xmlns:a16="http://schemas.microsoft.com/office/drawing/2014/main" id="{756F029D-97A2-7972-0D07-CC0C1AFE1B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3001" y="1514475"/>
            <a:ext cx="4929188" cy="1095375"/>
          </a:xfrm>
          <a:prstGeom prst="rect">
            <a:avLst/>
          </a:prstGeom>
        </p:spPr>
      </p:pic>
      <p:pic>
        <p:nvPicPr>
          <p:cNvPr id="10" name="圖片 9">
            <a:extLst>
              <a:ext uri="{FF2B5EF4-FFF2-40B4-BE49-F238E27FC236}">
                <a16:creationId xmlns:a16="http://schemas.microsoft.com/office/drawing/2014/main" id="{965AAAFA-F428-3FED-9651-B20CE9C8E8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64812" y="2892525"/>
            <a:ext cx="4929188" cy="1095375"/>
          </a:xfrm>
          <a:prstGeom prst="rect">
            <a:avLst/>
          </a:prstGeom>
        </p:spPr>
      </p:pic>
      <p:pic>
        <p:nvPicPr>
          <p:cNvPr id="11" name="圖片 10" descr="一張含有 文字, 螢幕擷取畫面, 字型, 數字 的圖片&#10;&#10;自動產生的描述">
            <a:extLst>
              <a:ext uri="{FF2B5EF4-FFF2-40B4-BE49-F238E27FC236}">
                <a16:creationId xmlns:a16="http://schemas.microsoft.com/office/drawing/2014/main" id="{D3F39F30-F790-4577-9913-ECD8E9762A8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1862" y="5100913"/>
            <a:ext cx="1646825" cy="756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99673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6E84AEB9-B07A-160A-3FDD-195974FC9146}"/>
              </a:ext>
            </a:extLst>
          </p:cNvPr>
          <p:cNvSpPr txBox="1"/>
          <p:nvPr/>
        </p:nvSpPr>
        <p:spPr>
          <a:xfrm>
            <a:off x="0" y="0"/>
            <a:ext cx="29354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ry Figure S4, continued)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7EB917B8-1DAB-7628-159C-D1937CC96C73}"/>
              </a:ext>
            </a:extLst>
          </p:cNvPr>
          <p:cNvSpPr txBox="1"/>
          <p:nvPr/>
        </p:nvSpPr>
        <p:spPr>
          <a:xfrm>
            <a:off x="0" y="376335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)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圖片 4" descr="一張含有 文字, 圖表, 螢幕擷取畫面, 正方形 的圖片&#10;&#10;自動產生的描述">
            <a:extLst>
              <a:ext uri="{FF2B5EF4-FFF2-40B4-BE49-F238E27FC236}">
                <a16:creationId xmlns:a16="http://schemas.microsoft.com/office/drawing/2014/main" id="{FE39C81D-9453-87EC-B97F-4973473E92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567" y="684112"/>
            <a:ext cx="4736433" cy="5277025"/>
          </a:xfrm>
          <a:prstGeom prst="rect">
            <a:avLst/>
          </a:prstGeom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id="{472F4E92-076D-041E-4C03-882E004BC4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3001" y="1562100"/>
            <a:ext cx="4929188" cy="1095375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23FC94B1-96B1-43E3-74FE-6687624AB60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53001" y="2965252"/>
            <a:ext cx="4929188" cy="1095375"/>
          </a:xfrm>
          <a:prstGeom prst="rect">
            <a:avLst/>
          </a:prstGeom>
        </p:spPr>
      </p:pic>
      <p:pic>
        <p:nvPicPr>
          <p:cNvPr id="8" name="圖片 7" descr="一張含有 文字, 螢幕擷取畫面, 字型, 數字 的圖片&#10;&#10;自動產生的描述">
            <a:extLst>
              <a:ext uri="{FF2B5EF4-FFF2-40B4-BE49-F238E27FC236}">
                <a16:creationId xmlns:a16="http://schemas.microsoft.com/office/drawing/2014/main" id="{56890890-8516-E4B6-1593-EB0227E223C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1862" y="5100913"/>
            <a:ext cx="1646825" cy="756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9052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佈景主題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</TotalTime>
  <Words>219</Words>
  <Application>Microsoft Office PowerPoint</Application>
  <PresentationFormat>A4 紙張 (210x297 公釐)</PresentationFormat>
  <Paragraphs>18</Paragraphs>
  <Slides>8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8</vt:i4>
      </vt:variant>
    </vt:vector>
  </HeadingPairs>
  <TitlesOfParts>
    <vt:vector size="13" baseType="lpstr">
      <vt:lpstr>Aptos</vt:lpstr>
      <vt:lpstr>Aptos Display</vt:lpstr>
      <vt:lpstr>Arial</vt:lpstr>
      <vt:lpstr>Times New Roman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瑋德 林</dc:creator>
  <cp:lastModifiedBy>瑋德 林</cp:lastModifiedBy>
  <cp:revision>4</cp:revision>
  <dcterms:created xsi:type="dcterms:W3CDTF">2024-06-08T16:11:33Z</dcterms:created>
  <dcterms:modified xsi:type="dcterms:W3CDTF">2024-06-09T10:15:15Z</dcterms:modified>
</cp:coreProperties>
</file>